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56" r:id="rId1"/>
  </p:sldMasterIdLst>
  <p:notesMasterIdLst>
    <p:notesMasterId r:id="rId3"/>
  </p:notesMasterIdLst>
  <p:sldIdLst>
    <p:sldId id="261" r:id="rId2"/>
  </p:sldIdLst>
  <p:sldSz cx="4389438" cy="86868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82D6"/>
    <a:srgbClr val="FF40FF"/>
    <a:srgbClr val="00FA00"/>
    <a:srgbClr val="0432FF"/>
    <a:srgbClr val="FF9300"/>
    <a:srgbClr val="FF7E79"/>
    <a:srgbClr val="23B696"/>
    <a:srgbClr val="1B92B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943"/>
    <p:restoredTop sz="96271"/>
  </p:normalViewPr>
  <p:slideViewPr>
    <p:cSldViewPr snapToGrid="0" snapToObjects="1">
      <p:cViewPr>
        <p:scale>
          <a:sx n="275" d="100"/>
          <a:sy n="275" d="100"/>
        </p:scale>
        <p:origin x="864" y="-5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dkko/Documents/*USDA_BRAG/ALS1%20trangenic%20lines_RNAseq/RNAseq/RNAseq%20data/3_cufflinks%20output/fpkm%20matrix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dkko/Documents/*USDA_BRAG/ALS1%20trangenic%20lines_RNAseq/RNAseq/RNAseq%20data/3_cufflinks%20output/fpkm%20matrix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dkko/Documents/*USDA_BRAG/ALS1%20trangenic%20lines_RNAseq/RNAseq/RNAseq%20data/3_cufflinks%20output/fpkm%20matrix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dkko/Documents/*USDA_BRAG/ALS1%20trangenic%20lines_RNAseq/RNAseq/RNAseq%20data/3_cufflinks%20output/fpkm%20matrix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dkko/Documents/*USDA_BRAG/ALS1%20trangenic%20lines_RNAseq/RNAseq/RNAseq%20data/fpkm%20matrix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dkko/Documents/*USDA_BRAG/ALS1%20trangenic%20lines_RNAseq/RNAseq/RNAseq%20data/fpkm%20matrix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dkko/Documents/*USDA_BRAG/ALS1%20trangenic%20lines_RNAseq/RNAseq/RNAseq%20data/fpkm%20matrix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dkko/Documents/*USDA_BRAG/ALS1%20trangenic%20lines_RNAseq/RNAseq/RNAseq%20data/fpkm%20matrix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479713473315798"/>
          <c:y val="0.180555555555556"/>
          <c:w val="0.60558508311461101"/>
          <c:h val="0.52747703412073499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'transgene locations'!$Y$7</c:f>
              <c:strCache>
                <c:ptCount val="1"/>
                <c:pt idx="0">
                  <c:v>avg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transgene locations'!$Z$6:$AA$6</c:f>
              <c:strCache>
                <c:ptCount val="2"/>
                <c:pt idx="0">
                  <c:v>WT</c:v>
                </c:pt>
                <c:pt idx="1">
                  <c:v>als1-15a</c:v>
                </c:pt>
              </c:strCache>
            </c:strRef>
          </c:cat>
          <c:val>
            <c:numRef>
              <c:f>'transgene locations'!$Z$7:$AA$7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DCD-3E40-A3FE-38475D3960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-665059008"/>
        <c:axId val="-667493456"/>
      </c:barChart>
      <c:catAx>
        <c:axId val="-66505900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667493456"/>
        <c:crosses val="autoZero"/>
        <c:auto val="1"/>
        <c:lblAlgn val="ctr"/>
        <c:lblOffset val="100"/>
        <c:noMultiLvlLbl val="0"/>
      </c:catAx>
      <c:valAx>
        <c:axId val="-66749345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6650590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Arial" charset="0"/>
          <a:ea typeface="Arial" charset="0"/>
          <a:cs typeface="Arial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479713473315798"/>
          <c:y val="0.180555555555556"/>
          <c:w val="0.61947397200349996"/>
          <c:h val="0.52747703412073499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'transgene locations'!$Y$7</c:f>
              <c:strCache>
                <c:ptCount val="1"/>
                <c:pt idx="0">
                  <c:v>avg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transgene locations'!$Z$6:$AA$6</c:f>
              <c:strCache>
                <c:ptCount val="2"/>
                <c:pt idx="0">
                  <c:v>WT</c:v>
                </c:pt>
                <c:pt idx="1">
                  <c:v>als1-15a</c:v>
                </c:pt>
              </c:strCache>
            </c:strRef>
          </c:cat>
          <c:val>
            <c:numRef>
              <c:f>'transgene locations'!$Z$7:$AA$7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04E-FE48-9A0C-C477E85687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-667670176"/>
        <c:axId val="-685135824"/>
      </c:barChart>
      <c:catAx>
        <c:axId val="-66767017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685135824"/>
        <c:crosses val="autoZero"/>
        <c:auto val="1"/>
        <c:lblAlgn val="ctr"/>
        <c:lblOffset val="100"/>
        <c:noMultiLvlLbl val="0"/>
      </c:catAx>
      <c:valAx>
        <c:axId val="-68513582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6676701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Arial" charset="0"/>
          <a:ea typeface="Arial" charset="0"/>
          <a:cs typeface="Arial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861657917760302"/>
          <c:y val="0.180555555555556"/>
          <c:w val="0.60176563867016597"/>
          <c:h val="0.52747703412073499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'transgene locations'!$G$50</c:f>
              <c:strCache>
                <c:ptCount val="1"/>
                <c:pt idx="0">
                  <c:v>avg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ransgene locations'!$H$51:$I$51</c:f>
                <c:numCache>
                  <c:formatCode>General</c:formatCode>
                  <c:ptCount val="2"/>
                  <c:pt idx="0">
                    <c:v>0.491738555256302</c:v>
                  </c:pt>
                  <c:pt idx="1">
                    <c:v>0.452652677159668</c:v>
                  </c:pt>
                </c:numCache>
              </c:numRef>
            </c:plus>
            <c:minus>
              <c:numRef>
                <c:f>'transgene locations'!$H$51:$I$51</c:f>
                <c:numCache>
                  <c:formatCode>General</c:formatCode>
                  <c:ptCount val="2"/>
                  <c:pt idx="0">
                    <c:v>0.491738555256302</c:v>
                  </c:pt>
                  <c:pt idx="1">
                    <c:v>0.452652677159668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transgene locations'!$H$49:$I$49</c:f>
              <c:strCache>
                <c:ptCount val="2"/>
                <c:pt idx="0">
                  <c:v>WT</c:v>
                </c:pt>
                <c:pt idx="1">
                  <c:v>als1-26</c:v>
                </c:pt>
              </c:strCache>
            </c:strRef>
          </c:cat>
          <c:val>
            <c:numRef>
              <c:f>'transgene locations'!$H$50:$I$50</c:f>
              <c:numCache>
                <c:formatCode>General</c:formatCode>
                <c:ptCount val="2"/>
                <c:pt idx="0">
                  <c:v>2.8867766666666661</c:v>
                </c:pt>
                <c:pt idx="1">
                  <c:v>2.2020666666666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761-9741-BE0B-33362CDD7E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-665627504"/>
        <c:axId val="-665119776"/>
      </c:barChart>
      <c:catAx>
        <c:axId val="-66562750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665119776"/>
        <c:crosses val="autoZero"/>
        <c:auto val="1"/>
        <c:lblAlgn val="ctr"/>
        <c:lblOffset val="100"/>
        <c:noMultiLvlLbl val="0"/>
      </c:catAx>
      <c:valAx>
        <c:axId val="-66511977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in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66562750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Arial" charset="0"/>
          <a:ea typeface="Arial" charset="0"/>
          <a:cs typeface="Arial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transgene locations'!$B$50</c:f>
              <c:strCache>
                <c:ptCount val="1"/>
                <c:pt idx="0">
                  <c:v>avg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ransgene locations'!$C$51:$D$51</c:f>
                <c:numCache>
                  <c:formatCode>General</c:formatCode>
                  <c:ptCount val="2"/>
                  <c:pt idx="0">
                    <c:v>0.44249891151152998</c:v>
                  </c:pt>
                  <c:pt idx="1">
                    <c:v>0.38400565144978199</c:v>
                  </c:pt>
                </c:numCache>
              </c:numRef>
            </c:plus>
            <c:minus>
              <c:numRef>
                <c:f>'transgene locations'!$C$51:$D$51</c:f>
                <c:numCache>
                  <c:formatCode>General</c:formatCode>
                  <c:ptCount val="2"/>
                  <c:pt idx="0">
                    <c:v>0.44249891151152998</c:v>
                  </c:pt>
                  <c:pt idx="1">
                    <c:v>0.38400565144978199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transgene locations'!$C$49:$D$49</c:f>
              <c:strCache>
                <c:ptCount val="2"/>
                <c:pt idx="0">
                  <c:v>WT</c:v>
                </c:pt>
                <c:pt idx="1">
                  <c:v>als1-26</c:v>
                </c:pt>
              </c:strCache>
            </c:strRef>
          </c:cat>
          <c:val>
            <c:numRef>
              <c:f>'transgene locations'!$C$50:$D$50</c:f>
              <c:numCache>
                <c:formatCode>General</c:formatCode>
                <c:ptCount val="2"/>
                <c:pt idx="0">
                  <c:v>2.479506666666667</c:v>
                </c:pt>
                <c:pt idx="1">
                  <c:v>1.69239666666666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7ED-B34B-9C3A-6FC0B4F2D3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-685530208"/>
        <c:axId val="-665406144"/>
      </c:barChart>
      <c:catAx>
        <c:axId val="-68553020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665406144"/>
        <c:crosses val="autoZero"/>
        <c:auto val="1"/>
        <c:lblAlgn val="ctr"/>
        <c:lblOffset val="100"/>
        <c:noMultiLvlLbl val="0"/>
      </c:catAx>
      <c:valAx>
        <c:axId val="-66540614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in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685530208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Arial" charset="0"/>
          <a:ea typeface="Arial" charset="0"/>
          <a:cs typeface="Arial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transgene locations'!$B$7</c:f>
              <c:strCache>
                <c:ptCount val="1"/>
                <c:pt idx="0">
                  <c:v>avg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ransgene locations'!$C$8:$D$8</c:f>
                <c:numCache>
                  <c:formatCode>General</c:formatCode>
                  <c:ptCount val="2"/>
                  <c:pt idx="0">
                    <c:v>2.2570977637087162</c:v>
                  </c:pt>
                  <c:pt idx="1">
                    <c:v>1.8692725281019531</c:v>
                  </c:pt>
                </c:numCache>
              </c:numRef>
            </c:plus>
            <c:minus>
              <c:numRef>
                <c:f>'transgene locations'!$C$8:$D$8</c:f>
                <c:numCache>
                  <c:formatCode>General</c:formatCode>
                  <c:ptCount val="2"/>
                  <c:pt idx="0">
                    <c:v>2.2570977637087162</c:v>
                  </c:pt>
                  <c:pt idx="1">
                    <c:v>1.8692725281019531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transgene locations'!$C$6:$D$6</c:f>
              <c:strCache>
                <c:ptCount val="2"/>
                <c:pt idx="0">
                  <c:v>WT</c:v>
                </c:pt>
                <c:pt idx="1">
                  <c:v>als1-1a</c:v>
                </c:pt>
              </c:strCache>
            </c:strRef>
          </c:cat>
          <c:val>
            <c:numRef>
              <c:f>'transgene locations'!$C$7:$D$7</c:f>
              <c:numCache>
                <c:formatCode>General</c:formatCode>
                <c:ptCount val="2"/>
                <c:pt idx="0">
                  <c:v>8.1300566666666665</c:v>
                </c:pt>
                <c:pt idx="1">
                  <c:v>5.70026333333334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4FF-684D-BC6A-C6C80F95DA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-665630400"/>
        <c:axId val="-665658976"/>
      </c:barChart>
      <c:catAx>
        <c:axId val="-665630400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665658976"/>
        <c:crosses val="autoZero"/>
        <c:auto val="1"/>
        <c:lblAlgn val="ctr"/>
        <c:lblOffset val="100"/>
        <c:noMultiLvlLbl val="0"/>
      </c:catAx>
      <c:valAx>
        <c:axId val="-66565897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in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6656304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Arial" charset="0"/>
          <a:ea typeface="Arial" charset="0"/>
          <a:cs typeface="Arial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861657917760302"/>
          <c:y val="0.181293895962999"/>
          <c:w val="0.61252952755905499"/>
          <c:h val="0.525544760156192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'transgene locations'!$G$7</c:f>
              <c:strCache>
                <c:ptCount val="1"/>
                <c:pt idx="0">
                  <c:v>avg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ransgene locations'!$H$8:$I$8</c:f>
                <c:numCache>
                  <c:formatCode>General</c:formatCode>
                  <c:ptCount val="2"/>
                  <c:pt idx="0">
                    <c:v>28.812886930705812</c:v>
                  </c:pt>
                  <c:pt idx="1">
                    <c:v>26.521897283378731</c:v>
                  </c:pt>
                </c:numCache>
              </c:numRef>
            </c:plus>
            <c:minus>
              <c:numRef>
                <c:f>'transgene locations'!$H$8:$I$8</c:f>
                <c:numCache>
                  <c:formatCode>General</c:formatCode>
                  <c:ptCount val="2"/>
                  <c:pt idx="0">
                    <c:v>28.812886930705812</c:v>
                  </c:pt>
                  <c:pt idx="1">
                    <c:v>26.521897283378731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transgene locations'!$H$6:$I$6</c:f>
              <c:strCache>
                <c:ptCount val="2"/>
                <c:pt idx="0">
                  <c:v>WT</c:v>
                </c:pt>
                <c:pt idx="1">
                  <c:v>als1-1a</c:v>
                </c:pt>
              </c:strCache>
            </c:strRef>
          </c:cat>
          <c:val>
            <c:numRef>
              <c:f>'transgene locations'!$H$7:$I$7</c:f>
              <c:numCache>
                <c:formatCode>General</c:formatCode>
                <c:ptCount val="2"/>
                <c:pt idx="0">
                  <c:v>92.248766666666668</c:v>
                </c:pt>
                <c:pt idx="1">
                  <c:v>88.7789666666666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589-534F-9382-8B1264F652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-1089465520"/>
        <c:axId val="-1127241232"/>
      </c:barChart>
      <c:catAx>
        <c:axId val="-1089465520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1127241232"/>
        <c:crosses val="autoZero"/>
        <c:auto val="1"/>
        <c:lblAlgn val="ctr"/>
        <c:lblOffset val="100"/>
        <c:noMultiLvlLbl val="0"/>
      </c:catAx>
      <c:valAx>
        <c:axId val="-1127241232"/>
        <c:scaling>
          <c:orientation val="minMax"/>
          <c:max val="15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1089465520"/>
        <c:crosses val="autoZero"/>
        <c:crossBetween val="between"/>
        <c:majorUnit val="4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Arial" charset="0"/>
          <a:ea typeface="Arial" charset="0"/>
          <a:cs typeface="Arial" charset="0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479713473315798"/>
          <c:y val="0.180555555555556"/>
          <c:w val="0.61947397200349996"/>
          <c:h val="0.52747703412073499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'transgene locations'!$M$7</c:f>
              <c:strCache>
                <c:ptCount val="1"/>
                <c:pt idx="0">
                  <c:v>avg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ransgene locations'!$N$8:$O$8</c:f>
                <c:numCache>
                  <c:formatCode>General</c:formatCode>
                  <c:ptCount val="2"/>
                  <c:pt idx="0">
                    <c:v>0.134763866195654</c:v>
                  </c:pt>
                  <c:pt idx="1">
                    <c:v>0.12173294555510999</c:v>
                  </c:pt>
                </c:numCache>
              </c:numRef>
            </c:plus>
            <c:minus>
              <c:numRef>
                <c:f>'transgene locations'!$N$8:$O$8</c:f>
                <c:numCache>
                  <c:formatCode>General</c:formatCode>
                  <c:ptCount val="2"/>
                  <c:pt idx="0">
                    <c:v>0.134763866195654</c:v>
                  </c:pt>
                  <c:pt idx="1">
                    <c:v>0.12173294555510999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ransgene locations'!$N$6:$O$6</c:f>
              <c:strCache>
                <c:ptCount val="2"/>
                <c:pt idx="0">
                  <c:v>WT</c:v>
                </c:pt>
                <c:pt idx="1">
                  <c:v>als1-10a</c:v>
                </c:pt>
              </c:strCache>
            </c:strRef>
          </c:cat>
          <c:val>
            <c:numRef>
              <c:f>'transgene locations'!$N$7:$O$7</c:f>
              <c:numCache>
                <c:formatCode>General</c:formatCode>
                <c:ptCount val="2"/>
                <c:pt idx="0">
                  <c:v>0.63367899999999999</c:v>
                </c:pt>
                <c:pt idx="1">
                  <c:v>0.31201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F02-244A-8D62-CDEE2609D3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-1089410848"/>
        <c:axId val="-1088580896"/>
      </c:barChart>
      <c:catAx>
        <c:axId val="-108941084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1088580896"/>
        <c:crosses val="autoZero"/>
        <c:auto val="1"/>
        <c:lblAlgn val="ctr"/>
        <c:lblOffset val="100"/>
        <c:noMultiLvlLbl val="0"/>
      </c:catAx>
      <c:valAx>
        <c:axId val="-108858089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in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1089410848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Arial" charset="0"/>
          <a:ea typeface="Arial" charset="0"/>
          <a:cs typeface="Arial" charset="0"/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479713473315798"/>
          <c:y val="0.20683180227471601"/>
          <c:w val="0.60246008311461097"/>
          <c:h val="0.57064523184601901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'transgene locations'!$R$7</c:f>
              <c:strCache>
                <c:ptCount val="1"/>
                <c:pt idx="0">
                  <c:v>avg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ransgene locations'!$S$8:$T$8</c:f>
                <c:numCache>
                  <c:formatCode>General</c:formatCode>
                  <c:ptCount val="2"/>
                  <c:pt idx="0">
                    <c:v>7.1766921654300098E-2</c:v>
                  </c:pt>
                  <c:pt idx="1">
                    <c:v>129.1970829443658</c:v>
                  </c:pt>
                </c:numCache>
              </c:numRef>
            </c:plus>
            <c:minus>
              <c:numRef>
                <c:f>'transgene locations'!$S$8:$T$8</c:f>
                <c:numCache>
                  <c:formatCode>General</c:formatCode>
                  <c:ptCount val="2"/>
                  <c:pt idx="0">
                    <c:v>7.1766921654300098E-2</c:v>
                  </c:pt>
                  <c:pt idx="1">
                    <c:v>129.1970829443658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ransgene locations'!$S$6:$T$6</c:f>
              <c:strCache>
                <c:ptCount val="2"/>
                <c:pt idx="0">
                  <c:v>WT</c:v>
                </c:pt>
                <c:pt idx="1">
                  <c:v>als1-10a</c:v>
                </c:pt>
              </c:strCache>
            </c:strRef>
          </c:cat>
          <c:val>
            <c:numRef>
              <c:f>'transgene locations'!$S$7:$T$7</c:f>
              <c:numCache>
                <c:formatCode>General</c:formatCode>
                <c:ptCount val="2"/>
                <c:pt idx="0">
                  <c:v>0.20033403333333299</c:v>
                </c:pt>
                <c:pt idx="1">
                  <c:v>291.052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E28-D348-B409-56913F8820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-1088834096"/>
        <c:axId val="-1089064592"/>
      </c:barChart>
      <c:catAx>
        <c:axId val="-108883409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1089064592"/>
        <c:crosses val="autoZero"/>
        <c:auto val="1"/>
        <c:lblAlgn val="ctr"/>
        <c:lblOffset val="100"/>
        <c:noMultiLvlLbl val="0"/>
      </c:catAx>
      <c:valAx>
        <c:axId val="-10890645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in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1088834096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Arial" charset="0"/>
          <a:ea typeface="Arial" charset="0"/>
          <a:cs typeface="Arial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7CD9DA-01E2-804A-82F6-7AE6D8A49595}" type="datetimeFigureOut">
              <a:rPr lang="en-US" smtClean="0"/>
              <a:t>8/6/18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649538" y="1143000"/>
            <a:ext cx="15589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6844D9-CF7B-394F-BA05-4B6C43079E5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776328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29208" y="1421660"/>
            <a:ext cx="3731022" cy="3024293"/>
          </a:xfrm>
        </p:spPr>
        <p:txBody>
          <a:bodyPr anchor="b"/>
          <a:lstStyle>
            <a:lvl1pPr algn="ctr"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48680" y="4562581"/>
            <a:ext cx="3292079" cy="2097299"/>
          </a:xfrm>
        </p:spPr>
        <p:txBody>
          <a:bodyPr/>
          <a:lstStyle>
            <a:lvl1pPr marL="0" indent="0" algn="ctr">
              <a:buNone/>
              <a:defRPr sz="1152"/>
            </a:lvl1pPr>
            <a:lvl2pPr marL="219456" indent="0" algn="ctr">
              <a:buNone/>
              <a:defRPr sz="960"/>
            </a:lvl2pPr>
            <a:lvl3pPr marL="438912" indent="0" algn="ctr">
              <a:buNone/>
              <a:defRPr sz="864"/>
            </a:lvl3pPr>
            <a:lvl4pPr marL="658368" indent="0" algn="ctr">
              <a:buNone/>
              <a:defRPr sz="768"/>
            </a:lvl4pPr>
            <a:lvl5pPr marL="877824" indent="0" algn="ctr">
              <a:buNone/>
              <a:defRPr sz="768"/>
            </a:lvl5pPr>
            <a:lvl6pPr marL="1097280" indent="0" algn="ctr">
              <a:buNone/>
              <a:defRPr sz="768"/>
            </a:lvl6pPr>
            <a:lvl7pPr marL="1316736" indent="0" algn="ctr">
              <a:buNone/>
              <a:defRPr sz="768"/>
            </a:lvl7pPr>
            <a:lvl8pPr marL="1536192" indent="0" algn="ctr">
              <a:buNone/>
              <a:defRPr sz="768"/>
            </a:lvl8pPr>
            <a:lvl9pPr marL="1755648" indent="0" algn="ctr">
              <a:buNone/>
              <a:defRPr sz="76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9724-28F0-B84F-89B2-F5D9320323B0}" type="datetimeFigureOut">
              <a:rPr lang="en-US" smtClean="0"/>
              <a:t>8/6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8BCA4-EA11-1148-AE4B-D5FDFB14F1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568138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9724-28F0-B84F-89B2-F5D9320323B0}" type="datetimeFigureOut">
              <a:rPr lang="en-US" smtClean="0"/>
              <a:t>8/6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8BCA4-EA11-1148-AE4B-D5FDFB14F1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30271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141192" y="462492"/>
            <a:ext cx="946473" cy="736166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01774" y="462492"/>
            <a:ext cx="2784550" cy="7361661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9724-28F0-B84F-89B2-F5D9320323B0}" type="datetimeFigureOut">
              <a:rPr lang="en-US" smtClean="0"/>
              <a:t>8/6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8BCA4-EA11-1148-AE4B-D5FDFB14F1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78262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9724-28F0-B84F-89B2-F5D9320323B0}" type="datetimeFigureOut">
              <a:rPr lang="en-US" smtClean="0"/>
              <a:t>8/6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8BCA4-EA11-1148-AE4B-D5FDFB14F1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795471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9488" y="2165670"/>
            <a:ext cx="3785890" cy="3613467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9488" y="5813322"/>
            <a:ext cx="3785890" cy="1900237"/>
          </a:xfrm>
        </p:spPr>
        <p:txBody>
          <a:bodyPr/>
          <a:lstStyle>
            <a:lvl1pPr marL="0" indent="0">
              <a:buNone/>
              <a:defRPr sz="1152">
                <a:solidFill>
                  <a:schemeClr val="tx1"/>
                </a:solidFill>
              </a:defRPr>
            </a:lvl1pPr>
            <a:lvl2pPr marL="219456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2pPr>
            <a:lvl3pPr marL="438912" indent="0">
              <a:buNone/>
              <a:defRPr sz="864">
                <a:solidFill>
                  <a:schemeClr val="tx1">
                    <a:tint val="75000"/>
                  </a:schemeClr>
                </a:solidFill>
              </a:defRPr>
            </a:lvl3pPr>
            <a:lvl4pPr marL="658368" indent="0">
              <a:buNone/>
              <a:defRPr sz="768">
                <a:solidFill>
                  <a:schemeClr val="tx1">
                    <a:tint val="75000"/>
                  </a:schemeClr>
                </a:solidFill>
              </a:defRPr>
            </a:lvl4pPr>
            <a:lvl5pPr marL="877824" indent="0">
              <a:buNone/>
              <a:defRPr sz="768">
                <a:solidFill>
                  <a:schemeClr val="tx1">
                    <a:tint val="75000"/>
                  </a:schemeClr>
                </a:solidFill>
              </a:defRPr>
            </a:lvl5pPr>
            <a:lvl6pPr marL="1097280" indent="0">
              <a:buNone/>
              <a:defRPr sz="768">
                <a:solidFill>
                  <a:schemeClr val="tx1">
                    <a:tint val="75000"/>
                  </a:schemeClr>
                </a:solidFill>
              </a:defRPr>
            </a:lvl6pPr>
            <a:lvl7pPr marL="1316736" indent="0">
              <a:buNone/>
              <a:defRPr sz="768">
                <a:solidFill>
                  <a:schemeClr val="tx1">
                    <a:tint val="75000"/>
                  </a:schemeClr>
                </a:solidFill>
              </a:defRPr>
            </a:lvl7pPr>
            <a:lvl8pPr marL="1536192" indent="0">
              <a:buNone/>
              <a:defRPr sz="768">
                <a:solidFill>
                  <a:schemeClr val="tx1">
                    <a:tint val="75000"/>
                  </a:schemeClr>
                </a:solidFill>
              </a:defRPr>
            </a:lvl8pPr>
            <a:lvl9pPr marL="1755648" indent="0">
              <a:buNone/>
              <a:defRPr sz="76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9724-28F0-B84F-89B2-F5D9320323B0}" type="datetimeFigureOut">
              <a:rPr lang="en-US" smtClean="0"/>
              <a:t>8/6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8BCA4-EA11-1148-AE4B-D5FDFB14F1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641545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01774" y="2312458"/>
            <a:ext cx="1865511" cy="551169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22153" y="2312458"/>
            <a:ext cx="1865511" cy="551169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9724-28F0-B84F-89B2-F5D9320323B0}" type="datetimeFigureOut">
              <a:rPr lang="en-US" smtClean="0"/>
              <a:t>8/6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8BCA4-EA11-1148-AE4B-D5FDFB14F1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60677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2346" y="462494"/>
            <a:ext cx="3785890" cy="167904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2346" y="2129473"/>
            <a:ext cx="1856938" cy="1043622"/>
          </a:xfrm>
        </p:spPr>
        <p:txBody>
          <a:bodyPr anchor="b"/>
          <a:lstStyle>
            <a:lvl1pPr marL="0" indent="0">
              <a:buNone/>
              <a:defRPr sz="1152" b="1"/>
            </a:lvl1pPr>
            <a:lvl2pPr marL="219456" indent="0">
              <a:buNone/>
              <a:defRPr sz="960" b="1"/>
            </a:lvl2pPr>
            <a:lvl3pPr marL="438912" indent="0">
              <a:buNone/>
              <a:defRPr sz="864" b="1"/>
            </a:lvl3pPr>
            <a:lvl4pPr marL="658368" indent="0">
              <a:buNone/>
              <a:defRPr sz="768" b="1"/>
            </a:lvl4pPr>
            <a:lvl5pPr marL="877824" indent="0">
              <a:buNone/>
              <a:defRPr sz="768" b="1"/>
            </a:lvl5pPr>
            <a:lvl6pPr marL="1097280" indent="0">
              <a:buNone/>
              <a:defRPr sz="768" b="1"/>
            </a:lvl6pPr>
            <a:lvl7pPr marL="1316736" indent="0">
              <a:buNone/>
              <a:defRPr sz="768" b="1"/>
            </a:lvl7pPr>
            <a:lvl8pPr marL="1536192" indent="0">
              <a:buNone/>
              <a:defRPr sz="768" b="1"/>
            </a:lvl8pPr>
            <a:lvl9pPr marL="1755648" indent="0">
              <a:buNone/>
              <a:defRPr sz="768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2346" y="3173095"/>
            <a:ext cx="1856938" cy="466714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222153" y="2129473"/>
            <a:ext cx="1866083" cy="1043622"/>
          </a:xfrm>
        </p:spPr>
        <p:txBody>
          <a:bodyPr anchor="b"/>
          <a:lstStyle>
            <a:lvl1pPr marL="0" indent="0">
              <a:buNone/>
              <a:defRPr sz="1152" b="1"/>
            </a:lvl1pPr>
            <a:lvl2pPr marL="219456" indent="0">
              <a:buNone/>
              <a:defRPr sz="960" b="1"/>
            </a:lvl2pPr>
            <a:lvl3pPr marL="438912" indent="0">
              <a:buNone/>
              <a:defRPr sz="864" b="1"/>
            </a:lvl3pPr>
            <a:lvl4pPr marL="658368" indent="0">
              <a:buNone/>
              <a:defRPr sz="768" b="1"/>
            </a:lvl4pPr>
            <a:lvl5pPr marL="877824" indent="0">
              <a:buNone/>
              <a:defRPr sz="768" b="1"/>
            </a:lvl5pPr>
            <a:lvl6pPr marL="1097280" indent="0">
              <a:buNone/>
              <a:defRPr sz="768" b="1"/>
            </a:lvl6pPr>
            <a:lvl7pPr marL="1316736" indent="0">
              <a:buNone/>
              <a:defRPr sz="768" b="1"/>
            </a:lvl7pPr>
            <a:lvl8pPr marL="1536192" indent="0">
              <a:buNone/>
              <a:defRPr sz="768" b="1"/>
            </a:lvl8pPr>
            <a:lvl9pPr marL="1755648" indent="0">
              <a:buNone/>
              <a:defRPr sz="768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222153" y="3173095"/>
            <a:ext cx="1866083" cy="466714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9724-28F0-B84F-89B2-F5D9320323B0}" type="datetimeFigureOut">
              <a:rPr lang="en-US" smtClean="0"/>
              <a:t>8/6/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8BCA4-EA11-1148-AE4B-D5FDFB14F1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25885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9724-28F0-B84F-89B2-F5D9320323B0}" type="datetimeFigureOut">
              <a:rPr lang="en-US" smtClean="0"/>
              <a:t>8/6/18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8BCA4-EA11-1148-AE4B-D5FDFB14F1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850074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9724-28F0-B84F-89B2-F5D9320323B0}" type="datetimeFigureOut">
              <a:rPr lang="en-US" smtClean="0"/>
              <a:t>8/6/18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8BCA4-EA11-1148-AE4B-D5FDFB14F1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958418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2346" y="579120"/>
            <a:ext cx="1415708" cy="2026920"/>
          </a:xfrm>
        </p:spPr>
        <p:txBody>
          <a:bodyPr anchor="b"/>
          <a:lstStyle>
            <a:lvl1pPr>
              <a:defRPr sz="153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866083" y="1250740"/>
            <a:ext cx="2222153" cy="6173258"/>
          </a:xfrm>
        </p:spPr>
        <p:txBody>
          <a:bodyPr/>
          <a:lstStyle>
            <a:lvl1pPr>
              <a:defRPr sz="1536"/>
            </a:lvl1pPr>
            <a:lvl2pPr>
              <a:defRPr sz="1344"/>
            </a:lvl2pPr>
            <a:lvl3pPr>
              <a:defRPr sz="1152"/>
            </a:lvl3pPr>
            <a:lvl4pPr>
              <a:defRPr sz="960"/>
            </a:lvl4pPr>
            <a:lvl5pPr>
              <a:defRPr sz="960"/>
            </a:lvl5pPr>
            <a:lvl6pPr>
              <a:defRPr sz="960"/>
            </a:lvl6pPr>
            <a:lvl7pPr>
              <a:defRPr sz="960"/>
            </a:lvl7pPr>
            <a:lvl8pPr>
              <a:defRPr sz="960"/>
            </a:lvl8pPr>
            <a:lvl9pPr>
              <a:defRPr sz="96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2346" y="2606040"/>
            <a:ext cx="1415708" cy="4828011"/>
          </a:xfrm>
        </p:spPr>
        <p:txBody>
          <a:bodyPr/>
          <a:lstStyle>
            <a:lvl1pPr marL="0" indent="0">
              <a:buNone/>
              <a:defRPr sz="768"/>
            </a:lvl1pPr>
            <a:lvl2pPr marL="219456" indent="0">
              <a:buNone/>
              <a:defRPr sz="672"/>
            </a:lvl2pPr>
            <a:lvl3pPr marL="438912" indent="0">
              <a:buNone/>
              <a:defRPr sz="576"/>
            </a:lvl3pPr>
            <a:lvl4pPr marL="658368" indent="0">
              <a:buNone/>
              <a:defRPr sz="480"/>
            </a:lvl4pPr>
            <a:lvl5pPr marL="877824" indent="0">
              <a:buNone/>
              <a:defRPr sz="480"/>
            </a:lvl5pPr>
            <a:lvl6pPr marL="1097280" indent="0">
              <a:buNone/>
              <a:defRPr sz="480"/>
            </a:lvl6pPr>
            <a:lvl7pPr marL="1316736" indent="0">
              <a:buNone/>
              <a:defRPr sz="480"/>
            </a:lvl7pPr>
            <a:lvl8pPr marL="1536192" indent="0">
              <a:buNone/>
              <a:defRPr sz="480"/>
            </a:lvl8pPr>
            <a:lvl9pPr marL="1755648" indent="0">
              <a:buNone/>
              <a:defRPr sz="48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9724-28F0-B84F-89B2-F5D9320323B0}" type="datetimeFigureOut">
              <a:rPr lang="en-US" smtClean="0"/>
              <a:t>8/6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8BCA4-EA11-1148-AE4B-D5FDFB14F1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116214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2346" y="579120"/>
            <a:ext cx="1415708" cy="2026920"/>
          </a:xfrm>
        </p:spPr>
        <p:txBody>
          <a:bodyPr anchor="b"/>
          <a:lstStyle>
            <a:lvl1pPr>
              <a:defRPr sz="153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866083" y="1250740"/>
            <a:ext cx="2222153" cy="6173258"/>
          </a:xfrm>
        </p:spPr>
        <p:txBody>
          <a:bodyPr anchor="t"/>
          <a:lstStyle>
            <a:lvl1pPr marL="0" indent="0">
              <a:buNone/>
              <a:defRPr sz="1536"/>
            </a:lvl1pPr>
            <a:lvl2pPr marL="219456" indent="0">
              <a:buNone/>
              <a:defRPr sz="1344"/>
            </a:lvl2pPr>
            <a:lvl3pPr marL="438912" indent="0">
              <a:buNone/>
              <a:defRPr sz="1152"/>
            </a:lvl3pPr>
            <a:lvl4pPr marL="658368" indent="0">
              <a:buNone/>
              <a:defRPr sz="960"/>
            </a:lvl4pPr>
            <a:lvl5pPr marL="877824" indent="0">
              <a:buNone/>
              <a:defRPr sz="960"/>
            </a:lvl5pPr>
            <a:lvl6pPr marL="1097280" indent="0">
              <a:buNone/>
              <a:defRPr sz="960"/>
            </a:lvl6pPr>
            <a:lvl7pPr marL="1316736" indent="0">
              <a:buNone/>
              <a:defRPr sz="960"/>
            </a:lvl7pPr>
            <a:lvl8pPr marL="1536192" indent="0">
              <a:buNone/>
              <a:defRPr sz="960"/>
            </a:lvl8pPr>
            <a:lvl9pPr marL="1755648" indent="0">
              <a:buNone/>
              <a:defRPr sz="9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2346" y="2606040"/>
            <a:ext cx="1415708" cy="4828011"/>
          </a:xfrm>
        </p:spPr>
        <p:txBody>
          <a:bodyPr/>
          <a:lstStyle>
            <a:lvl1pPr marL="0" indent="0">
              <a:buNone/>
              <a:defRPr sz="768"/>
            </a:lvl1pPr>
            <a:lvl2pPr marL="219456" indent="0">
              <a:buNone/>
              <a:defRPr sz="672"/>
            </a:lvl2pPr>
            <a:lvl3pPr marL="438912" indent="0">
              <a:buNone/>
              <a:defRPr sz="576"/>
            </a:lvl3pPr>
            <a:lvl4pPr marL="658368" indent="0">
              <a:buNone/>
              <a:defRPr sz="480"/>
            </a:lvl4pPr>
            <a:lvl5pPr marL="877824" indent="0">
              <a:buNone/>
              <a:defRPr sz="480"/>
            </a:lvl5pPr>
            <a:lvl6pPr marL="1097280" indent="0">
              <a:buNone/>
              <a:defRPr sz="480"/>
            </a:lvl6pPr>
            <a:lvl7pPr marL="1316736" indent="0">
              <a:buNone/>
              <a:defRPr sz="480"/>
            </a:lvl7pPr>
            <a:lvl8pPr marL="1536192" indent="0">
              <a:buNone/>
              <a:defRPr sz="480"/>
            </a:lvl8pPr>
            <a:lvl9pPr marL="1755648" indent="0">
              <a:buNone/>
              <a:defRPr sz="48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9724-28F0-B84F-89B2-F5D9320323B0}" type="datetimeFigureOut">
              <a:rPr lang="en-US" smtClean="0"/>
              <a:t>8/6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8BCA4-EA11-1148-AE4B-D5FDFB14F1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644338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01774" y="462494"/>
            <a:ext cx="3785890" cy="167904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1774" y="2312458"/>
            <a:ext cx="3785890" cy="551169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01774" y="8051378"/>
            <a:ext cx="987624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7B9724-28F0-B84F-89B2-F5D9320323B0}" type="datetimeFigureOut">
              <a:rPr lang="en-US" smtClean="0"/>
              <a:t>8/6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454002" y="8051378"/>
            <a:ext cx="1481435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100040" y="8051378"/>
            <a:ext cx="987624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78BCA4-EA11-1148-AE4B-D5FDFB14F1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24682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438912" rtl="0" eaLnBrk="1" latinLnBrk="0" hangingPunct="1">
        <a:lnSpc>
          <a:spcPct val="90000"/>
        </a:lnSpc>
        <a:spcBef>
          <a:spcPct val="0"/>
        </a:spcBef>
        <a:buNone/>
        <a:defRPr sz="211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9728" indent="-109728" algn="l" defTabSz="438912" rtl="0" eaLnBrk="1" latinLnBrk="0" hangingPunct="1">
        <a:lnSpc>
          <a:spcPct val="90000"/>
        </a:lnSpc>
        <a:spcBef>
          <a:spcPts val="480"/>
        </a:spcBef>
        <a:buFont typeface="Arial" panose="020B0604020202020204" pitchFamily="34" charset="0"/>
        <a:buChar char="•"/>
        <a:defRPr sz="1344" kern="1200">
          <a:solidFill>
            <a:schemeClr val="tx1"/>
          </a:solidFill>
          <a:latin typeface="+mn-lt"/>
          <a:ea typeface="+mn-ea"/>
          <a:cs typeface="+mn-cs"/>
        </a:defRPr>
      </a:lvl1pPr>
      <a:lvl2pPr marL="329184" indent="-109728" algn="l" defTabSz="438912" rtl="0" eaLnBrk="1" latinLnBrk="0" hangingPunct="1">
        <a:lnSpc>
          <a:spcPct val="90000"/>
        </a:lnSpc>
        <a:spcBef>
          <a:spcPts val="240"/>
        </a:spcBef>
        <a:buFont typeface="Arial" panose="020B0604020202020204" pitchFamily="34" charset="0"/>
        <a:buChar char="•"/>
        <a:defRPr sz="1152" kern="1200">
          <a:solidFill>
            <a:schemeClr val="tx1"/>
          </a:solidFill>
          <a:latin typeface="+mn-lt"/>
          <a:ea typeface="+mn-ea"/>
          <a:cs typeface="+mn-cs"/>
        </a:defRPr>
      </a:lvl2pPr>
      <a:lvl3pPr marL="548640" indent="-109728" algn="l" defTabSz="438912" rtl="0" eaLnBrk="1" latinLnBrk="0" hangingPunct="1">
        <a:lnSpc>
          <a:spcPct val="90000"/>
        </a:lnSpc>
        <a:spcBef>
          <a:spcPts val="240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3pPr>
      <a:lvl4pPr marL="768096" indent="-109728" algn="l" defTabSz="438912" rtl="0" eaLnBrk="1" latinLnBrk="0" hangingPunct="1">
        <a:lnSpc>
          <a:spcPct val="90000"/>
        </a:lnSpc>
        <a:spcBef>
          <a:spcPts val="240"/>
        </a:spcBef>
        <a:buFont typeface="Arial" panose="020B0604020202020204" pitchFamily="34" charset="0"/>
        <a:buChar char="•"/>
        <a:defRPr sz="864" kern="1200">
          <a:solidFill>
            <a:schemeClr val="tx1"/>
          </a:solidFill>
          <a:latin typeface="+mn-lt"/>
          <a:ea typeface="+mn-ea"/>
          <a:cs typeface="+mn-cs"/>
        </a:defRPr>
      </a:lvl4pPr>
      <a:lvl5pPr marL="987552" indent="-109728" algn="l" defTabSz="438912" rtl="0" eaLnBrk="1" latinLnBrk="0" hangingPunct="1">
        <a:lnSpc>
          <a:spcPct val="90000"/>
        </a:lnSpc>
        <a:spcBef>
          <a:spcPts val="240"/>
        </a:spcBef>
        <a:buFont typeface="Arial" panose="020B0604020202020204" pitchFamily="34" charset="0"/>
        <a:buChar char="•"/>
        <a:defRPr sz="864" kern="1200">
          <a:solidFill>
            <a:schemeClr val="tx1"/>
          </a:solidFill>
          <a:latin typeface="+mn-lt"/>
          <a:ea typeface="+mn-ea"/>
          <a:cs typeface="+mn-cs"/>
        </a:defRPr>
      </a:lvl5pPr>
      <a:lvl6pPr marL="1207008" indent="-109728" algn="l" defTabSz="438912" rtl="0" eaLnBrk="1" latinLnBrk="0" hangingPunct="1">
        <a:lnSpc>
          <a:spcPct val="90000"/>
        </a:lnSpc>
        <a:spcBef>
          <a:spcPts val="240"/>
        </a:spcBef>
        <a:buFont typeface="Arial" panose="020B0604020202020204" pitchFamily="34" charset="0"/>
        <a:buChar char="•"/>
        <a:defRPr sz="864" kern="1200">
          <a:solidFill>
            <a:schemeClr val="tx1"/>
          </a:solidFill>
          <a:latin typeface="+mn-lt"/>
          <a:ea typeface="+mn-ea"/>
          <a:cs typeface="+mn-cs"/>
        </a:defRPr>
      </a:lvl6pPr>
      <a:lvl7pPr marL="1426464" indent="-109728" algn="l" defTabSz="438912" rtl="0" eaLnBrk="1" latinLnBrk="0" hangingPunct="1">
        <a:lnSpc>
          <a:spcPct val="90000"/>
        </a:lnSpc>
        <a:spcBef>
          <a:spcPts val="240"/>
        </a:spcBef>
        <a:buFont typeface="Arial" panose="020B0604020202020204" pitchFamily="34" charset="0"/>
        <a:buChar char="•"/>
        <a:defRPr sz="864" kern="1200">
          <a:solidFill>
            <a:schemeClr val="tx1"/>
          </a:solidFill>
          <a:latin typeface="+mn-lt"/>
          <a:ea typeface="+mn-ea"/>
          <a:cs typeface="+mn-cs"/>
        </a:defRPr>
      </a:lvl7pPr>
      <a:lvl8pPr marL="1645920" indent="-109728" algn="l" defTabSz="438912" rtl="0" eaLnBrk="1" latinLnBrk="0" hangingPunct="1">
        <a:lnSpc>
          <a:spcPct val="90000"/>
        </a:lnSpc>
        <a:spcBef>
          <a:spcPts val="240"/>
        </a:spcBef>
        <a:buFont typeface="Arial" panose="020B0604020202020204" pitchFamily="34" charset="0"/>
        <a:buChar char="•"/>
        <a:defRPr sz="864" kern="1200">
          <a:solidFill>
            <a:schemeClr val="tx1"/>
          </a:solidFill>
          <a:latin typeface="+mn-lt"/>
          <a:ea typeface="+mn-ea"/>
          <a:cs typeface="+mn-cs"/>
        </a:defRPr>
      </a:lvl8pPr>
      <a:lvl9pPr marL="1865376" indent="-109728" algn="l" defTabSz="438912" rtl="0" eaLnBrk="1" latinLnBrk="0" hangingPunct="1">
        <a:lnSpc>
          <a:spcPct val="90000"/>
        </a:lnSpc>
        <a:spcBef>
          <a:spcPts val="240"/>
        </a:spcBef>
        <a:buFont typeface="Arial" panose="020B0604020202020204" pitchFamily="34" charset="0"/>
        <a:buChar char="•"/>
        <a:defRPr sz="86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38912" rtl="0" eaLnBrk="1" latinLnBrk="0" hangingPunct="1">
        <a:defRPr sz="864" kern="1200">
          <a:solidFill>
            <a:schemeClr val="tx1"/>
          </a:solidFill>
          <a:latin typeface="+mn-lt"/>
          <a:ea typeface="+mn-ea"/>
          <a:cs typeface="+mn-cs"/>
        </a:defRPr>
      </a:lvl1pPr>
      <a:lvl2pPr marL="219456" algn="l" defTabSz="438912" rtl="0" eaLnBrk="1" latinLnBrk="0" hangingPunct="1">
        <a:defRPr sz="864" kern="1200">
          <a:solidFill>
            <a:schemeClr val="tx1"/>
          </a:solidFill>
          <a:latin typeface="+mn-lt"/>
          <a:ea typeface="+mn-ea"/>
          <a:cs typeface="+mn-cs"/>
        </a:defRPr>
      </a:lvl2pPr>
      <a:lvl3pPr marL="438912" algn="l" defTabSz="438912" rtl="0" eaLnBrk="1" latinLnBrk="0" hangingPunct="1">
        <a:defRPr sz="864" kern="1200">
          <a:solidFill>
            <a:schemeClr val="tx1"/>
          </a:solidFill>
          <a:latin typeface="+mn-lt"/>
          <a:ea typeface="+mn-ea"/>
          <a:cs typeface="+mn-cs"/>
        </a:defRPr>
      </a:lvl3pPr>
      <a:lvl4pPr marL="658368" algn="l" defTabSz="438912" rtl="0" eaLnBrk="1" latinLnBrk="0" hangingPunct="1">
        <a:defRPr sz="864" kern="1200">
          <a:solidFill>
            <a:schemeClr val="tx1"/>
          </a:solidFill>
          <a:latin typeface="+mn-lt"/>
          <a:ea typeface="+mn-ea"/>
          <a:cs typeface="+mn-cs"/>
        </a:defRPr>
      </a:lvl4pPr>
      <a:lvl5pPr marL="877824" algn="l" defTabSz="438912" rtl="0" eaLnBrk="1" latinLnBrk="0" hangingPunct="1">
        <a:defRPr sz="864" kern="1200">
          <a:solidFill>
            <a:schemeClr val="tx1"/>
          </a:solidFill>
          <a:latin typeface="+mn-lt"/>
          <a:ea typeface="+mn-ea"/>
          <a:cs typeface="+mn-cs"/>
        </a:defRPr>
      </a:lvl5pPr>
      <a:lvl6pPr marL="1097280" algn="l" defTabSz="438912" rtl="0" eaLnBrk="1" latinLnBrk="0" hangingPunct="1">
        <a:defRPr sz="864" kern="1200">
          <a:solidFill>
            <a:schemeClr val="tx1"/>
          </a:solidFill>
          <a:latin typeface="+mn-lt"/>
          <a:ea typeface="+mn-ea"/>
          <a:cs typeface="+mn-cs"/>
        </a:defRPr>
      </a:lvl6pPr>
      <a:lvl7pPr marL="1316736" algn="l" defTabSz="438912" rtl="0" eaLnBrk="1" latinLnBrk="0" hangingPunct="1">
        <a:defRPr sz="864" kern="1200">
          <a:solidFill>
            <a:schemeClr val="tx1"/>
          </a:solidFill>
          <a:latin typeface="+mn-lt"/>
          <a:ea typeface="+mn-ea"/>
          <a:cs typeface="+mn-cs"/>
        </a:defRPr>
      </a:lvl7pPr>
      <a:lvl8pPr marL="1536192" algn="l" defTabSz="438912" rtl="0" eaLnBrk="1" latinLnBrk="0" hangingPunct="1">
        <a:defRPr sz="864" kern="1200">
          <a:solidFill>
            <a:schemeClr val="tx1"/>
          </a:solidFill>
          <a:latin typeface="+mn-lt"/>
          <a:ea typeface="+mn-ea"/>
          <a:cs typeface="+mn-cs"/>
        </a:defRPr>
      </a:lvl8pPr>
      <a:lvl9pPr marL="1755648" algn="l" defTabSz="438912" rtl="0" eaLnBrk="1" latinLnBrk="0" hangingPunct="1">
        <a:defRPr sz="86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5" name="Chart 1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61209158"/>
              </p:ext>
            </p:extLst>
          </p:nvPr>
        </p:nvGraphicFramePr>
        <p:xfrm>
          <a:off x="2547898" y="5505233"/>
          <a:ext cx="1828800" cy="914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4" name="Chart 1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98310620"/>
              </p:ext>
            </p:extLst>
          </p:nvPr>
        </p:nvGraphicFramePr>
        <p:xfrm>
          <a:off x="-2571" y="5503685"/>
          <a:ext cx="1828800" cy="914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7" name="Chart 1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23433524"/>
              </p:ext>
            </p:extLst>
          </p:nvPr>
        </p:nvGraphicFramePr>
        <p:xfrm>
          <a:off x="2547898" y="7613008"/>
          <a:ext cx="1828800" cy="914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6" name="Chart 1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3705987"/>
              </p:ext>
            </p:extLst>
          </p:nvPr>
        </p:nvGraphicFramePr>
        <p:xfrm>
          <a:off x="-2571" y="7608383"/>
          <a:ext cx="1828800" cy="914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4" name="Chart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7512833"/>
              </p:ext>
            </p:extLst>
          </p:nvPr>
        </p:nvGraphicFramePr>
        <p:xfrm>
          <a:off x="2547898" y="1240489"/>
          <a:ext cx="1828800" cy="9115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5" name="Chart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36907241"/>
              </p:ext>
            </p:extLst>
          </p:nvPr>
        </p:nvGraphicFramePr>
        <p:xfrm>
          <a:off x="-2571" y="1223841"/>
          <a:ext cx="1828800" cy="9106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59" name="Chart 5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8319195"/>
              </p:ext>
            </p:extLst>
          </p:nvPr>
        </p:nvGraphicFramePr>
        <p:xfrm>
          <a:off x="6665" y="3281508"/>
          <a:ext cx="1828800" cy="914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60" name="Chart 5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9042206"/>
              </p:ext>
            </p:extLst>
          </p:nvPr>
        </p:nvGraphicFramePr>
        <p:xfrm>
          <a:off x="2547898" y="3229524"/>
          <a:ext cx="1828800" cy="914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cxnSp>
        <p:nvCxnSpPr>
          <p:cNvPr id="3" name="Straight Connector 2"/>
          <p:cNvCxnSpPr/>
          <p:nvPr/>
        </p:nvCxnSpPr>
        <p:spPr>
          <a:xfrm flipV="1">
            <a:off x="367271" y="857734"/>
            <a:ext cx="36576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 flipV="1">
            <a:off x="1833550" y="853572"/>
            <a:ext cx="366464" cy="2449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ight Arrow 5"/>
          <p:cNvSpPr/>
          <p:nvPr/>
        </p:nvSpPr>
        <p:spPr>
          <a:xfrm flipH="1">
            <a:off x="672178" y="756074"/>
            <a:ext cx="685093" cy="195015"/>
          </a:xfrm>
          <a:prstGeom prst="rightArrow">
            <a:avLst>
              <a:gd name="adj1" fmla="val 74077"/>
              <a:gd name="adj2" fmla="val 5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Right Arrow 6"/>
          <p:cNvSpPr/>
          <p:nvPr/>
        </p:nvSpPr>
        <p:spPr>
          <a:xfrm>
            <a:off x="3120226" y="756074"/>
            <a:ext cx="731520" cy="195015"/>
          </a:xfrm>
          <a:prstGeom prst="rightArrow">
            <a:avLst>
              <a:gd name="adj1" fmla="val 74077"/>
              <a:gd name="adj2" fmla="val 5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1925791" y="1101549"/>
            <a:ext cx="530053" cy="171771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T-DNA</a:t>
            </a:r>
          </a:p>
        </p:txBody>
      </p:sp>
      <p:sp>
        <p:nvSpPr>
          <p:cNvPr id="9" name="Rectangle 8"/>
          <p:cNvSpPr/>
          <p:nvPr/>
        </p:nvSpPr>
        <p:spPr>
          <a:xfrm rot="10800000">
            <a:off x="1835556" y="1100014"/>
            <a:ext cx="91440" cy="173307"/>
          </a:xfrm>
          <a:prstGeom prst="rect">
            <a:avLst/>
          </a:prstGeom>
          <a:solidFill>
            <a:schemeClr val="accent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" name="Rectangle 9"/>
          <p:cNvSpPr/>
          <p:nvPr/>
        </p:nvSpPr>
        <p:spPr>
          <a:xfrm rot="10800000">
            <a:off x="2455835" y="1100013"/>
            <a:ext cx="91440" cy="172485"/>
          </a:xfrm>
          <a:prstGeom prst="rect">
            <a:avLst/>
          </a:prstGeom>
          <a:solidFill>
            <a:schemeClr val="accent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1" name="Straight Connector 10"/>
          <p:cNvCxnSpPr/>
          <p:nvPr/>
        </p:nvCxnSpPr>
        <p:spPr>
          <a:xfrm flipH="1" flipV="1">
            <a:off x="2190817" y="860002"/>
            <a:ext cx="355197" cy="2400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195952" y="1000078"/>
            <a:ext cx="16308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i="1" dirty="0">
                <a:latin typeface="Arial" charset="0"/>
                <a:ea typeface="Arial" charset="0"/>
                <a:cs typeface="Arial" charset="0"/>
              </a:rPr>
              <a:t>PGSC0003DMG400014340</a:t>
            </a:r>
          </a:p>
          <a:p>
            <a:pPr algn="ctr"/>
            <a:r>
              <a:rPr lang="de-DE" sz="800" dirty="0">
                <a:latin typeface="Arial" charset="0"/>
                <a:ea typeface="Arial" charset="0"/>
                <a:cs typeface="Arial" charset="0"/>
              </a:rPr>
              <a:t>(Cytochrome B561)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728852" y="1000078"/>
            <a:ext cx="16582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i="1" dirty="0">
                <a:latin typeface="Arial" charset="0"/>
                <a:ea typeface="Arial" charset="0"/>
                <a:cs typeface="Arial" charset="0"/>
              </a:rPr>
              <a:t>PGSC0003DMG400014292 </a:t>
            </a:r>
          </a:p>
          <a:p>
            <a:pPr algn="ctr"/>
            <a:r>
              <a:rPr lang="de-DE" sz="800" dirty="0">
                <a:latin typeface="Arial" charset="0"/>
                <a:ea typeface="Arial" charset="0"/>
                <a:cs typeface="Arial" charset="0"/>
              </a:rPr>
              <a:t>(ATP binding protein)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5" name="Straight Connector 14"/>
          <p:cNvCxnSpPr/>
          <p:nvPr/>
        </p:nvCxnSpPr>
        <p:spPr>
          <a:xfrm flipV="1">
            <a:off x="2188408" y="599949"/>
            <a:ext cx="1" cy="257064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3635850" y="412035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 kb</a:t>
            </a:r>
          </a:p>
        </p:txBody>
      </p:sp>
      <p:sp>
        <p:nvSpPr>
          <p:cNvPr id="18" name="Rounded Rectangle 17"/>
          <p:cNvSpPr/>
          <p:nvPr/>
        </p:nvSpPr>
        <p:spPr>
          <a:xfrm>
            <a:off x="1106488" y="210036"/>
            <a:ext cx="905356" cy="171084"/>
          </a:xfrm>
          <a:prstGeom prst="roundRect">
            <a:avLst>
              <a:gd name="adj" fmla="val 50000"/>
            </a:avLst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9" name="Rounded Rectangle 18"/>
          <p:cNvSpPr/>
          <p:nvPr/>
        </p:nvSpPr>
        <p:spPr>
          <a:xfrm>
            <a:off x="2014347" y="208267"/>
            <a:ext cx="1731024" cy="171085"/>
          </a:xfrm>
          <a:prstGeom prst="roundRect">
            <a:avLst>
              <a:gd name="adj" fmla="val 50000"/>
            </a:avLst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1669505" y="594259"/>
            <a:ext cx="1058303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charset="0"/>
                <a:ea typeface="Arial" charset="0"/>
                <a:cs typeface="Arial" charset="0"/>
              </a:rPr>
              <a:t>Chr03: 42,911,422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21" name="Straight Connector 20"/>
          <p:cNvCxnSpPr/>
          <p:nvPr/>
        </p:nvCxnSpPr>
        <p:spPr>
          <a:xfrm>
            <a:off x="3083776" y="155960"/>
            <a:ext cx="0" cy="27432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>
            <a:endCxn id="20" idx="0"/>
          </p:cNvCxnSpPr>
          <p:nvPr/>
        </p:nvCxnSpPr>
        <p:spPr>
          <a:xfrm flipH="1">
            <a:off x="2198657" y="430027"/>
            <a:ext cx="889089" cy="164241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416536" y="187856"/>
            <a:ext cx="1183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i="1" dirty="0">
                <a:latin typeface="Arial" charset="0"/>
                <a:ea typeface="Arial" charset="0"/>
                <a:cs typeface="Arial" charset="0"/>
              </a:rPr>
              <a:t>als1-1a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V="1">
            <a:off x="367271" y="2928348"/>
            <a:ext cx="36576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flipV="1">
            <a:off x="2244753" y="2937940"/>
            <a:ext cx="366464" cy="2449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ight Arrow 31"/>
          <p:cNvSpPr/>
          <p:nvPr/>
        </p:nvSpPr>
        <p:spPr>
          <a:xfrm flipH="1">
            <a:off x="716794" y="2826688"/>
            <a:ext cx="685093" cy="195015"/>
          </a:xfrm>
          <a:prstGeom prst="rightArrow">
            <a:avLst>
              <a:gd name="adj1" fmla="val 74077"/>
              <a:gd name="adj2" fmla="val 5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4" name="Rectangle 33"/>
          <p:cNvSpPr/>
          <p:nvPr/>
        </p:nvSpPr>
        <p:spPr>
          <a:xfrm>
            <a:off x="2336994" y="3187360"/>
            <a:ext cx="530053" cy="171771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T-DNA</a:t>
            </a:r>
          </a:p>
        </p:txBody>
      </p:sp>
      <p:sp>
        <p:nvSpPr>
          <p:cNvPr id="35" name="Rectangle 34"/>
          <p:cNvSpPr/>
          <p:nvPr/>
        </p:nvSpPr>
        <p:spPr>
          <a:xfrm rot="10800000">
            <a:off x="2246759" y="3184373"/>
            <a:ext cx="94344" cy="174758"/>
          </a:xfrm>
          <a:prstGeom prst="rect">
            <a:avLst/>
          </a:prstGeom>
          <a:solidFill>
            <a:schemeClr val="accent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6" name="Rectangle 35"/>
          <p:cNvSpPr/>
          <p:nvPr/>
        </p:nvSpPr>
        <p:spPr>
          <a:xfrm rot="10800000">
            <a:off x="2867038" y="3184381"/>
            <a:ext cx="91440" cy="172485"/>
          </a:xfrm>
          <a:prstGeom prst="rect">
            <a:avLst/>
          </a:prstGeom>
          <a:solidFill>
            <a:schemeClr val="accent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37" name="Straight Connector 36"/>
          <p:cNvCxnSpPr/>
          <p:nvPr/>
        </p:nvCxnSpPr>
        <p:spPr>
          <a:xfrm flipH="1" flipV="1">
            <a:off x="2602020" y="2944370"/>
            <a:ext cx="355197" cy="2400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195952" y="3035792"/>
            <a:ext cx="16308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PGSC0003DMG400021979</a:t>
            </a:r>
            <a:endParaRPr lang="de-DE" sz="800" i="1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de-DE" sz="800" dirty="0">
                <a:latin typeface="Arial" charset="0"/>
                <a:ea typeface="Arial" charset="0"/>
                <a:cs typeface="Arial" charset="0"/>
              </a:rPr>
              <a:t>(Auxin-induced SAUR)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787535" y="3035792"/>
            <a:ext cx="16582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PGSC0003DMG400021980</a:t>
            </a:r>
            <a:endParaRPr lang="de-DE" sz="800" i="1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de-DE" sz="800" dirty="0">
                <a:latin typeface="Arial" charset="0"/>
                <a:ea typeface="Arial" charset="0"/>
                <a:cs typeface="Arial" charset="0"/>
              </a:rPr>
              <a:t>(Auxin-induced SAUR)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3" name="Rounded Rectangle 42"/>
          <p:cNvSpPr/>
          <p:nvPr/>
        </p:nvSpPr>
        <p:spPr>
          <a:xfrm>
            <a:off x="1106488" y="2286961"/>
            <a:ext cx="1133240" cy="171084"/>
          </a:xfrm>
          <a:prstGeom prst="roundRect">
            <a:avLst>
              <a:gd name="adj" fmla="val 50000"/>
            </a:avLst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4" name="Rounded Rectangle 43"/>
          <p:cNvSpPr/>
          <p:nvPr/>
        </p:nvSpPr>
        <p:spPr>
          <a:xfrm>
            <a:off x="2243013" y="2287653"/>
            <a:ext cx="1498663" cy="171085"/>
          </a:xfrm>
          <a:prstGeom prst="roundRect">
            <a:avLst>
              <a:gd name="adj" fmla="val 50000"/>
            </a:avLst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46" name="Straight Connector 45"/>
          <p:cNvCxnSpPr/>
          <p:nvPr/>
        </p:nvCxnSpPr>
        <p:spPr>
          <a:xfrm>
            <a:off x="3128392" y="2235344"/>
            <a:ext cx="0" cy="27432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416529" y="2264781"/>
            <a:ext cx="5934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charset="0"/>
                <a:ea typeface="Arial" charset="0"/>
                <a:cs typeface="Arial" charset="0"/>
              </a:rPr>
              <a:t>als1-10a</a:t>
            </a:r>
          </a:p>
        </p:txBody>
      </p:sp>
      <p:cxnSp>
        <p:nvCxnSpPr>
          <p:cNvPr id="50" name="Straight Connector 49"/>
          <p:cNvCxnSpPr/>
          <p:nvPr/>
        </p:nvCxnSpPr>
        <p:spPr>
          <a:xfrm>
            <a:off x="3667498" y="626644"/>
            <a:ext cx="2743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 flipV="1">
            <a:off x="2610020" y="2653232"/>
            <a:ext cx="1205" cy="281728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2118416" y="2639372"/>
            <a:ext cx="1042273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charset="0"/>
                <a:ea typeface="Arial" charset="0"/>
                <a:cs typeface="Arial" charset="0"/>
              </a:rPr>
              <a:t>Chr10: 44,433,457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3578202" y="2495182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0.7 kb</a:t>
            </a:r>
          </a:p>
        </p:txBody>
      </p:sp>
      <p:cxnSp>
        <p:nvCxnSpPr>
          <p:cNvPr id="58" name="Straight Connector 57"/>
          <p:cNvCxnSpPr/>
          <p:nvPr/>
        </p:nvCxnSpPr>
        <p:spPr>
          <a:xfrm>
            <a:off x="3667498" y="2709791"/>
            <a:ext cx="2743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 flipV="1">
            <a:off x="367271" y="5059074"/>
            <a:ext cx="36576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 flipV="1">
            <a:off x="1979646" y="5054912"/>
            <a:ext cx="366464" cy="2449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Right Arrow 70"/>
          <p:cNvSpPr/>
          <p:nvPr/>
        </p:nvSpPr>
        <p:spPr>
          <a:xfrm rot="10800000" flipH="1">
            <a:off x="732212" y="4957414"/>
            <a:ext cx="685093" cy="195015"/>
          </a:xfrm>
          <a:prstGeom prst="rightArrow">
            <a:avLst>
              <a:gd name="adj1" fmla="val 74077"/>
              <a:gd name="adj2" fmla="val 5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2" name="Right Arrow 71"/>
          <p:cNvSpPr/>
          <p:nvPr/>
        </p:nvSpPr>
        <p:spPr>
          <a:xfrm rot="10800000">
            <a:off x="3089520" y="4957414"/>
            <a:ext cx="731520" cy="195015"/>
          </a:xfrm>
          <a:prstGeom prst="rightArrow">
            <a:avLst>
              <a:gd name="adj1" fmla="val 74077"/>
              <a:gd name="adj2" fmla="val 5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3" name="Rectangle 72"/>
          <p:cNvSpPr/>
          <p:nvPr/>
        </p:nvSpPr>
        <p:spPr>
          <a:xfrm>
            <a:off x="2071887" y="5302889"/>
            <a:ext cx="530053" cy="171771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T-DNA</a:t>
            </a:r>
          </a:p>
        </p:txBody>
      </p:sp>
      <p:sp>
        <p:nvSpPr>
          <p:cNvPr id="74" name="Rectangle 73"/>
          <p:cNvSpPr/>
          <p:nvPr/>
        </p:nvSpPr>
        <p:spPr>
          <a:xfrm rot="10800000">
            <a:off x="1981652" y="5301354"/>
            <a:ext cx="91440" cy="173307"/>
          </a:xfrm>
          <a:prstGeom prst="rect">
            <a:avLst/>
          </a:prstGeom>
          <a:solidFill>
            <a:schemeClr val="accent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5" name="Rectangle 74"/>
          <p:cNvSpPr/>
          <p:nvPr/>
        </p:nvSpPr>
        <p:spPr>
          <a:xfrm rot="10800000">
            <a:off x="2601931" y="5301353"/>
            <a:ext cx="91440" cy="172485"/>
          </a:xfrm>
          <a:prstGeom prst="rect">
            <a:avLst/>
          </a:prstGeom>
          <a:solidFill>
            <a:schemeClr val="accent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76" name="Straight Connector 75"/>
          <p:cNvCxnSpPr/>
          <p:nvPr/>
        </p:nvCxnSpPr>
        <p:spPr>
          <a:xfrm flipH="1" flipV="1">
            <a:off x="2336913" y="5061342"/>
            <a:ext cx="355197" cy="2400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195952" y="5201427"/>
            <a:ext cx="16308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PGSC0003DMG400037026</a:t>
            </a:r>
            <a:endParaRPr lang="de-DE" sz="800" i="1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de-DE" sz="800" dirty="0">
                <a:latin typeface="Arial" charset="0"/>
                <a:ea typeface="Arial" charset="0"/>
                <a:cs typeface="Arial" charset="0"/>
              </a:rPr>
              <a:t>(Putrescine N-methyltransferase)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2844138" y="5201418"/>
            <a:ext cx="16582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s-IS" sz="800" i="1">
                <a:latin typeface="Arial" charset="0"/>
                <a:ea typeface="Arial" charset="0"/>
                <a:cs typeface="Arial" charset="0"/>
              </a:rPr>
              <a:t>PGSC0003DMG400040080</a:t>
            </a:r>
            <a:endParaRPr lang="de-DE" sz="800" i="1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de-DE" sz="800" dirty="0">
                <a:latin typeface="Arial" charset="0"/>
                <a:ea typeface="Arial" charset="0"/>
                <a:cs typeface="Arial" charset="0"/>
              </a:rPr>
              <a:t>(Unknown function)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79" name="Straight Connector 78"/>
          <p:cNvCxnSpPr/>
          <p:nvPr/>
        </p:nvCxnSpPr>
        <p:spPr>
          <a:xfrm flipH="1" flipV="1">
            <a:off x="2334504" y="4749835"/>
            <a:ext cx="2409" cy="311498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3580609" y="4646621"/>
            <a:ext cx="4379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5 kb</a:t>
            </a:r>
          </a:p>
        </p:txBody>
      </p:sp>
      <p:sp>
        <p:nvSpPr>
          <p:cNvPr id="81" name="Rounded Rectangle 80"/>
          <p:cNvSpPr/>
          <p:nvPr/>
        </p:nvSpPr>
        <p:spPr>
          <a:xfrm>
            <a:off x="1106488" y="4375075"/>
            <a:ext cx="877170" cy="171084"/>
          </a:xfrm>
          <a:prstGeom prst="roundRect">
            <a:avLst>
              <a:gd name="adj" fmla="val 50000"/>
            </a:avLst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2" name="Rounded Rectangle 81"/>
          <p:cNvSpPr/>
          <p:nvPr/>
        </p:nvSpPr>
        <p:spPr>
          <a:xfrm>
            <a:off x="1987861" y="4375084"/>
            <a:ext cx="1754733" cy="171085"/>
          </a:xfrm>
          <a:prstGeom prst="roundRect">
            <a:avLst>
              <a:gd name="adj" fmla="val 50000"/>
            </a:avLst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3" name="TextBox 82"/>
          <p:cNvSpPr txBox="1"/>
          <p:nvPr/>
        </p:nvSpPr>
        <p:spPr>
          <a:xfrm>
            <a:off x="1815601" y="4795599"/>
            <a:ext cx="1042273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charset="0"/>
                <a:ea typeface="Arial" charset="0"/>
                <a:cs typeface="Arial" charset="0"/>
              </a:rPr>
              <a:t>Chr06: </a:t>
            </a:r>
            <a:r>
              <a:rPr lang="fi-FI" sz="800" dirty="0">
                <a:latin typeface="Arial" charset="0"/>
                <a:ea typeface="Arial" charset="0"/>
                <a:cs typeface="Arial" charset="0"/>
              </a:rPr>
              <a:t>39,382,926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84" name="Straight Connector 83"/>
          <p:cNvCxnSpPr/>
          <p:nvPr/>
        </p:nvCxnSpPr>
        <p:spPr>
          <a:xfrm>
            <a:off x="2512943" y="4325372"/>
            <a:ext cx="0" cy="27432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/>
          <p:cNvCxnSpPr/>
          <p:nvPr/>
        </p:nvCxnSpPr>
        <p:spPr>
          <a:xfrm flipH="1">
            <a:off x="2341103" y="4601057"/>
            <a:ext cx="171840" cy="148778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85"/>
          <p:cNvSpPr txBox="1"/>
          <p:nvPr/>
        </p:nvSpPr>
        <p:spPr>
          <a:xfrm>
            <a:off x="416529" y="4352895"/>
            <a:ext cx="5934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charset="0"/>
                <a:ea typeface="Arial" charset="0"/>
                <a:cs typeface="Arial" charset="0"/>
              </a:rPr>
              <a:t>als1-15a</a:t>
            </a:r>
          </a:p>
        </p:txBody>
      </p:sp>
      <p:cxnSp>
        <p:nvCxnSpPr>
          <p:cNvPr id="87" name="Straight Connector 86"/>
          <p:cNvCxnSpPr/>
          <p:nvPr/>
        </p:nvCxnSpPr>
        <p:spPr>
          <a:xfrm>
            <a:off x="3667498" y="4861230"/>
            <a:ext cx="2743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92"/>
          <p:cNvSpPr txBox="1"/>
          <p:nvPr/>
        </p:nvSpPr>
        <p:spPr>
          <a:xfrm>
            <a:off x="67535" y="141697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94" name="TextBox 93"/>
          <p:cNvSpPr txBox="1"/>
          <p:nvPr/>
        </p:nvSpPr>
        <p:spPr>
          <a:xfrm>
            <a:off x="67535" y="2218624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67535" y="430673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sp>
        <p:nvSpPr>
          <p:cNvPr id="33" name="Right Arrow 32"/>
          <p:cNvSpPr/>
          <p:nvPr/>
        </p:nvSpPr>
        <p:spPr>
          <a:xfrm rot="10800000">
            <a:off x="2719921" y="2826688"/>
            <a:ext cx="731520" cy="195015"/>
          </a:xfrm>
          <a:prstGeom prst="rightArrow">
            <a:avLst>
              <a:gd name="adj1" fmla="val 74077"/>
              <a:gd name="adj2" fmla="val 5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47" name="Straight Connector 46"/>
          <p:cNvCxnSpPr/>
          <p:nvPr/>
        </p:nvCxnSpPr>
        <p:spPr>
          <a:xfrm flipH="1">
            <a:off x="2602011" y="2511199"/>
            <a:ext cx="526382" cy="140808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/>
          <p:cNvCxnSpPr/>
          <p:nvPr/>
        </p:nvCxnSpPr>
        <p:spPr>
          <a:xfrm flipV="1">
            <a:off x="367271" y="7227098"/>
            <a:ext cx="36576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/>
          <p:cNvCxnSpPr/>
          <p:nvPr/>
        </p:nvCxnSpPr>
        <p:spPr>
          <a:xfrm flipV="1">
            <a:off x="1993018" y="7222936"/>
            <a:ext cx="366464" cy="2449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Right Arrow 95"/>
          <p:cNvSpPr/>
          <p:nvPr/>
        </p:nvSpPr>
        <p:spPr>
          <a:xfrm rot="10800000" flipH="1">
            <a:off x="745584" y="7125438"/>
            <a:ext cx="685093" cy="195015"/>
          </a:xfrm>
          <a:prstGeom prst="rightArrow">
            <a:avLst>
              <a:gd name="adj1" fmla="val 74077"/>
              <a:gd name="adj2" fmla="val 5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7" name="Right Arrow 96"/>
          <p:cNvSpPr/>
          <p:nvPr/>
        </p:nvSpPr>
        <p:spPr>
          <a:xfrm rot="10800000" flipH="1">
            <a:off x="3193632" y="7125438"/>
            <a:ext cx="731520" cy="195015"/>
          </a:xfrm>
          <a:prstGeom prst="rightArrow">
            <a:avLst>
              <a:gd name="adj1" fmla="val 74077"/>
              <a:gd name="adj2" fmla="val 5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8" name="Rectangle 97"/>
          <p:cNvSpPr/>
          <p:nvPr/>
        </p:nvSpPr>
        <p:spPr>
          <a:xfrm>
            <a:off x="2085259" y="7470913"/>
            <a:ext cx="530053" cy="171771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T-DNA</a:t>
            </a:r>
          </a:p>
        </p:txBody>
      </p:sp>
      <p:sp>
        <p:nvSpPr>
          <p:cNvPr id="99" name="Rectangle 98"/>
          <p:cNvSpPr/>
          <p:nvPr/>
        </p:nvSpPr>
        <p:spPr>
          <a:xfrm rot="10800000">
            <a:off x="1995024" y="7469378"/>
            <a:ext cx="91440" cy="173307"/>
          </a:xfrm>
          <a:prstGeom prst="rect">
            <a:avLst/>
          </a:prstGeom>
          <a:solidFill>
            <a:schemeClr val="accent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0" name="Rectangle 99"/>
          <p:cNvSpPr/>
          <p:nvPr/>
        </p:nvSpPr>
        <p:spPr>
          <a:xfrm rot="10800000">
            <a:off x="2615303" y="7469377"/>
            <a:ext cx="91440" cy="172485"/>
          </a:xfrm>
          <a:prstGeom prst="rect">
            <a:avLst/>
          </a:prstGeom>
          <a:solidFill>
            <a:schemeClr val="accent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01" name="Straight Connector 100"/>
          <p:cNvCxnSpPr/>
          <p:nvPr/>
        </p:nvCxnSpPr>
        <p:spPr>
          <a:xfrm flipH="1" flipV="1">
            <a:off x="2350285" y="7229366"/>
            <a:ext cx="355197" cy="2400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01"/>
          <p:cNvSpPr txBox="1"/>
          <p:nvPr/>
        </p:nvSpPr>
        <p:spPr>
          <a:xfrm>
            <a:off x="195952" y="7369442"/>
            <a:ext cx="16308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i="1" dirty="0">
                <a:latin typeface="Arial" charset="0"/>
                <a:ea typeface="Arial" charset="0"/>
                <a:cs typeface="Arial" charset="0"/>
              </a:rPr>
              <a:t>PGSC0003DMG402012908</a:t>
            </a:r>
          </a:p>
          <a:p>
            <a:pPr algn="ctr"/>
            <a:r>
              <a:rPr lang="de-DE" sz="800" dirty="0">
                <a:latin typeface="Arial" charset="0"/>
                <a:ea typeface="Arial" charset="0"/>
                <a:cs typeface="Arial" charset="0"/>
              </a:rPr>
              <a:t>(Serine carboxypeptidase)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2844138" y="7369442"/>
            <a:ext cx="16582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800" i="1" dirty="0">
                <a:latin typeface="Arial" charset="0"/>
                <a:ea typeface="Arial" charset="0"/>
                <a:cs typeface="Arial" charset="0"/>
              </a:rPr>
              <a:t>PGSC0003DMG402012907</a:t>
            </a:r>
            <a:endParaRPr lang="de-DE" sz="800" i="1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de-DE" sz="800" dirty="0">
                <a:latin typeface="Arial" charset="0"/>
                <a:ea typeface="Arial" charset="0"/>
                <a:cs typeface="Arial" charset="0"/>
              </a:rPr>
              <a:t>(Unknown function)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04" name="Straight Connector 103"/>
          <p:cNvCxnSpPr/>
          <p:nvPr/>
        </p:nvCxnSpPr>
        <p:spPr>
          <a:xfrm flipH="1" flipV="1">
            <a:off x="2347876" y="6917859"/>
            <a:ext cx="2409" cy="311498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3577472" y="6797553"/>
            <a:ext cx="4379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5 kb</a:t>
            </a:r>
          </a:p>
        </p:txBody>
      </p:sp>
      <p:sp>
        <p:nvSpPr>
          <p:cNvPr id="106" name="Rounded Rectangle 105"/>
          <p:cNvSpPr/>
          <p:nvPr/>
        </p:nvSpPr>
        <p:spPr>
          <a:xfrm>
            <a:off x="1106488" y="6559008"/>
            <a:ext cx="1093526" cy="171084"/>
          </a:xfrm>
          <a:prstGeom prst="roundRect">
            <a:avLst>
              <a:gd name="adj" fmla="val 50000"/>
            </a:avLst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7" name="Rounded Rectangle 106"/>
          <p:cNvSpPr/>
          <p:nvPr/>
        </p:nvSpPr>
        <p:spPr>
          <a:xfrm>
            <a:off x="2205248" y="6559017"/>
            <a:ext cx="1539743" cy="171085"/>
          </a:xfrm>
          <a:prstGeom prst="roundRect">
            <a:avLst>
              <a:gd name="adj" fmla="val 50000"/>
            </a:avLst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8" name="TextBox 107"/>
          <p:cNvSpPr txBox="1"/>
          <p:nvPr/>
        </p:nvSpPr>
        <p:spPr>
          <a:xfrm>
            <a:off x="1828973" y="6963623"/>
            <a:ext cx="1042273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charset="0"/>
                <a:ea typeface="Arial" charset="0"/>
                <a:cs typeface="Arial" charset="0"/>
              </a:rPr>
              <a:t>Chr04: </a:t>
            </a:r>
            <a:r>
              <a:rPr lang="fi-FI" sz="800" dirty="0">
                <a:latin typeface="Arial" charset="0"/>
                <a:ea typeface="Arial" charset="0"/>
                <a:cs typeface="Arial" charset="0"/>
              </a:rPr>
              <a:t>64,830,170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09" name="Straight Connector 108"/>
          <p:cNvCxnSpPr/>
          <p:nvPr/>
        </p:nvCxnSpPr>
        <p:spPr>
          <a:xfrm>
            <a:off x="3310751" y="6507356"/>
            <a:ext cx="0" cy="27432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/>
          <p:cNvCxnSpPr/>
          <p:nvPr/>
        </p:nvCxnSpPr>
        <p:spPr>
          <a:xfrm flipH="1">
            <a:off x="2466155" y="6781685"/>
            <a:ext cx="839156" cy="136183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110"/>
          <p:cNvSpPr txBox="1"/>
          <p:nvPr/>
        </p:nvSpPr>
        <p:spPr>
          <a:xfrm>
            <a:off x="416529" y="6536828"/>
            <a:ext cx="5357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charset="0"/>
                <a:ea typeface="Arial" charset="0"/>
                <a:cs typeface="Arial" charset="0"/>
              </a:rPr>
              <a:t>als1-26</a:t>
            </a:r>
          </a:p>
        </p:txBody>
      </p:sp>
      <p:cxnSp>
        <p:nvCxnSpPr>
          <p:cNvPr id="112" name="Straight Connector 111"/>
          <p:cNvCxnSpPr/>
          <p:nvPr/>
        </p:nvCxnSpPr>
        <p:spPr>
          <a:xfrm>
            <a:off x="3667498" y="7012162"/>
            <a:ext cx="2743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12"/>
          <p:cNvSpPr txBox="1"/>
          <p:nvPr/>
        </p:nvSpPr>
        <p:spPr>
          <a:xfrm>
            <a:off x="67535" y="649067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sp>
        <p:nvSpPr>
          <p:cNvPr id="119" name="TextBox 118"/>
          <p:cNvSpPr txBox="1"/>
          <p:nvPr/>
        </p:nvSpPr>
        <p:spPr>
          <a:xfrm>
            <a:off x="827455" y="8415061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FPKM</a:t>
            </a:r>
          </a:p>
        </p:txBody>
      </p:sp>
      <p:sp>
        <p:nvSpPr>
          <p:cNvPr id="120" name="TextBox 119"/>
          <p:cNvSpPr txBox="1"/>
          <p:nvPr/>
        </p:nvSpPr>
        <p:spPr>
          <a:xfrm>
            <a:off x="3397438" y="8415061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FPKM</a:t>
            </a:r>
          </a:p>
        </p:txBody>
      </p:sp>
      <p:sp>
        <p:nvSpPr>
          <p:cNvPr id="118" name="TextBox 117"/>
          <p:cNvSpPr txBox="1"/>
          <p:nvPr/>
        </p:nvSpPr>
        <p:spPr>
          <a:xfrm>
            <a:off x="827455" y="6296566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FPKM</a:t>
            </a:r>
          </a:p>
        </p:txBody>
      </p:sp>
      <p:sp>
        <p:nvSpPr>
          <p:cNvPr id="121" name="TextBox 120"/>
          <p:cNvSpPr txBox="1"/>
          <p:nvPr/>
        </p:nvSpPr>
        <p:spPr>
          <a:xfrm>
            <a:off x="3397438" y="6296566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FPKM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827455" y="4085743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FPKM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3397438" y="4085743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FPKM</a:t>
            </a:r>
          </a:p>
        </p:txBody>
      </p:sp>
      <p:sp>
        <p:nvSpPr>
          <p:cNvPr id="124" name="TextBox 123"/>
          <p:cNvSpPr txBox="1"/>
          <p:nvPr/>
        </p:nvSpPr>
        <p:spPr>
          <a:xfrm>
            <a:off x="827455" y="1998596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FPKM</a:t>
            </a:r>
          </a:p>
        </p:txBody>
      </p:sp>
      <p:sp>
        <p:nvSpPr>
          <p:cNvPr id="125" name="TextBox 124"/>
          <p:cNvSpPr txBox="1"/>
          <p:nvPr/>
        </p:nvSpPr>
        <p:spPr>
          <a:xfrm>
            <a:off x="3397438" y="1998596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FPKM</a:t>
            </a:r>
          </a:p>
        </p:txBody>
      </p:sp>
    </p:spTree>
    <p:extLst>
      <p:ext uri="{BB962C8B-B14F-4D97-AF65-F5344CB8AC3E}">
        <p14:creationId xmlns:p14="http://schemas.microsoft.com/office/powerpoint/2010/main" val="10815525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965</TotalTime>
  <Words>81</Words>
  <Application>Microsoft Macintosh PowerPoint</Application>
  <PresentationFormat>Custom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e Kwan Ko</dc:creator>
  <cp:lastModifiedBy>Dae Kwan Ko</cp:lastModifiedBy>
  <cp:revision>418</cp:revision>
  <dcterms:created xsi:type="dcterms:W3CDTF">2017-06-23T16:58:21Z</dcterms:created>
  <dcterms:modified xsi:type="dcterms:W3CDTF">2018-08-06T18:11:56Z</dcterms:modified>
</cp:coreProperties>
</file>